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36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177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692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563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3717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804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2165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69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055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795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1831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6795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8D7EA-EE41-4888-85E5-3D7C80F36E0D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1DEF7B-F22B-49B3-8C6D-700355F10A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693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247" y="342632"/>
            <a:ext cx="8463506" cy="555546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41020" y="5934670"/>
            <a:ext cx="882396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trends in total, LDL and HDL cholesterol between 2005 and 2019, Bus Santé study, Geneva, Switzerland. Results are expressed as multivariate-adjusted mean and 95% confidence interval.  All trends are significant at p&lt;0.001.</a:t>
            </a:r>
            <a:endParaRPr lang="fr-CH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43375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dro Marques-Vidal</dc:creator>
  <cp:lastModifiedBy>Pedro Marques-Vidal</cp:lastModifiedBy>
  <cp:revision>3</cp:revision>
  <dcterms:created xsi:type="dcterms:W3CDTF">2022-02-25T06:47:36Z</dcterms:created>
  <dcterms:modified xsi:type="dcterms:W3CDTF">2022-08-24T12:04:13Z</dcterms:modified>
</cp:coreProperties>
</file>